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5"/>
  </p:normalViewPr>
  <p:slideViewPr>
    <p:cSldViewPr snapToGrid="0" snapToObjects="1" showGuides="1">
      <p:cViewPr varScale="1">
        <p:scale>
          <a:sx n="103" d="100"/>
          <a:sy n="103" d="100"/>
        </p:scale>
        <p:origin x="800" y="168"/>
      </p:cViewPr>
      <p:guideLst>
        <p:guide orient="horz" pos="104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871581-0FA7-454E-8BCC-8681BFD506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54BE1F8-49DB-6648-982C-D2C7157103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721B3F-15D0-B946-B9A8-CE438D824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933C01-D914-6348-8A96-83B713F61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8E891-A1C8-EE42-8F07-09C6FFF24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71269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D2C5C8-4484-A24C-838D-85D225D94C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9780C5-8A14-8E48-A781-0D77C1BB80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C3FA1B-A2B8-7441-85A9-BF3840DB9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399D86-B150-E24D-9954-271E84D03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B8E021-2F01-144E-9724-245A3E48E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79338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0EC3CF6-6A8D-B14E-9B73-F833D8D52A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4DF29E-5DB4-BE44-BA01-9F8FD74BA2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C592AD-CCBD-B64E-993D-AC2DA157F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E5955D-8749-A040-A540-65171D9D8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BE0E58-1374-D047-8A3B-CAAEEC1EE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49151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70AABC-3E47-FC4D-8064-49BC69796D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403EBA4-0AA2-8A46-80B1-87DE02CE4A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91758B6-F56E-B444-8DBF-FA3A9C606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8EC4B9-A932-FA43-A297-64BDCD162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E990B3-31B8-CA49-A3DE-3A5ABE57A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57701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59D79D-33A6-6A43-B9AF-AEB5815A7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17470D-475B-AF4D-B35C-13D0F16A43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D3630A-7BB1-C844-ABD1-4A2B06B08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FEF918-D843-404C-BBFD-10DF9BD20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9A0DE5-03DB-624A-8BCA-B7B101D5F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47949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3DD7AE-22DA-5A44-8518-75BDB92461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26BD6F7-12F6-4E4F-9C7D-2180063316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1C75CB5-C69C-D94B-9715-0EEDC88624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83748F-5B6C-244F-8818-A0BE05F71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5B3E927-F689-0442-A3A0-970858A70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CF475A1-2AF0-584B-BBD3-83263E9F5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68733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4A4752-DB02-7B4D-ADFA-0E0CF6375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752E410-3DE9-8241-B571-FA490C9B16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BF816D4-F94E-FC4F-97F6-5BB4468F08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071DF34-0634-6A4A-8BAA-C9B1FD2E91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68AFBC5-4758-6B4A-B4FD-1CE775DF19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B319C14-3D7A-3B4F-B6E2-875B60098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875B54-9261-D344-A12B-E4F8C3DF6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CC7D654-2A93-E548-ABE7-7A26E7D50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43496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06864C-6D68-9D47-844F-9BC57FA5A9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7DDD107-9F58-EA4A-B748-43AE87B05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463AD07-51F8-D641-858D-8D8BFEE88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9B4E593-736D-124E-B6D2-1D3173273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33405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BED080F-2189-8841-9EC3-174D179CB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23FF972-8B2E-F548-9556-46091F3D9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1A74927-4B0C-0840-A540-190B7B035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63440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3B74A7-6124-F24A-9CA0-ABF2D0422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FEB9EA5-4B46-D645-937B-748C9BBFB8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314390F-8687-394E-96CE-5D507F4274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E2BC4F-396C-9D43-B41B-8AF00E441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0EACDA0-78C7-714E-80BA-087DA9171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22CD052-0C62-8C4A-8204-A57461468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81868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413540-A63E-A740-BFA9-3E3BD574B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7F9FC00-F480-4D45-A04B-3CA673D519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92DFC46-E938-0045-B35B-048ED21610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47E382A-CC14-BB4F-82C6-7937329A79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11C44BF-6902-3E40-87B9-1A94CC024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258B084-5001-824F-B832-3FF534CED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99656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B1E044D-806F-2C4D-9786-B7C8832666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B4E999-6A53-DF4C-96A9-69342098C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96FBC0-4793-D348-A00A-3B44BC6942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51030-488B-344E-966A-33BFCAF77165}" type="datetimeFigureOut">
              <a:rPr kumimoji="1" lang="zh-CN" altLang="en-US" smtClean="0"/>
              <a:t>2022/3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CD0AD2-6296-304C-B786-A03092F07D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EAB36A-C4BA-D34B-92C1-BAADA45C23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ED355-04C0-A644-9C56-826359A7E32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05841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格 8">
            <a:extLst>
              <a:ext uri="{FF2B5EF4-FFF2-40B4-BE49-F238E27FC236}">
                <a16:creationId xmlns:a16="http://schemas.microsoft.com/office/drawing/2014/main" id="{DA018C6C-B2F2-6841-9008-BC18D36251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8540989"/>
              </p:ext>
            </p:extLst>
          </p:nvPr>
        </p:nvGraphicFramePr>
        <p:xfrm>
          <a:off x="1786264" y="1276977"/>
          <a:ext cx="9098854" cy="435931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209539">
                  <a:extLst>
                    <a:ext uri="{9D8B030D-6E8A-4147-A177-3AD203B41FA5}">
                      <a16:colId xmlns:a16="http://schemas.microsoft.com/office/drawing/2014/main" val="436312695"/>
                    </a:ext>
                  </a:extLst>
                </a:gridCol>
                <a:gridCol w="3269293">
                  <a:extLst>
                    <a:ext uri="{9D8B030D-6E8A-4147-A177-3AD203B41FA5}">
                      <a16:colId xmlns:a16="http://schemas.microsoft.com/office/drawing/2014/main" val="1264531433"/>
                    </a:ext>
                  </a:extLst>
                </a:gridCol>
                <a:gridCol w="3620022">
                  <a:extLst>
                    <a:ext uri="{9D8B030D-6E8A-4147-A177-3AD203B41FA5}">
                      <a16:colId xmlns:a16="http://schemas.microsoft.com/office/drawing/2014/main" val="1519727857"/>
                    </a:ext>
                  </a:extLst>
                </a:gridCol>
              </a:tblGrid>
              <a:tr h="290621">
                <a:tc rowSpan="2"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ID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52024372"/>
                  </a:ext>
                </a:extLst>
              </a:tr>
              <a:tr h="290621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orward primer (5' to 3')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 (5' to 3')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3561597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28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ATCACCCCATTCAAAGGCT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AACCACGCTCCTTTTATCG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7537041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29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CAGGTGGTTGTTTCTGG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AGTAGTCGTCTCCGCAA</a:t>
                      </a:r>
                      <a:endParaRPr lang="zh-CN" sz="14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228543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0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AGCATCAATGTCACCCGCG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AGTTTGTGGCGTCGAGTAG</a:t>
                      </a:r>
                      <a:endParaRPr lang="zh-CN" sz="14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9958908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1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ATGACTACTTGACGCC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GACTCTGTTGGGCAAAA</a:t>
                      </a:r>
                      <a:endParaRPr lang="zh-CN" sz="14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3502193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2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CTGTCACATTAGCCCAGA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TAACCACCTGCAACTCCGG</a:t>
                      </a:r>
                      <a:endParaRPr lang="zh-CN" sz="14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5574524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3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CAGTTTTGTTGTACGGA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GGAGCAAGTGAGAGTACT</a:t>
                      </a:r>
                      <a:endParaRPr lang="zh-CN" sz="14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0359496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7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TCGATGGCTATAACATGAGGA</a:t>
                      </a:r>
                      <a:endParaRPr lang="zh-CN" sz="14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CAATGTCTGTTCAAGTCCG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9361675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8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AAATGTTCAAGAATGCCTGC</a:t>
                      </a:r>
                      <a:endParaRPr lang="zh-CN" sz="1400" b="1" kern="100"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GTGAAGGAGTCGGGCAAAA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8232754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9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CATGGATTTCTACGACGTC</a:t>
                      </a:r>
                      <a:endParaRPr lang="zh-CN" sz="1400" b="1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TGCGTACTGACAATCACCA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0281163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PAL1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altLang="zh-CN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GGAACGGATTTGCTAACAGGC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altLang="zh-CN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CAGCATCGGGTCAATCAACT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3781480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PAL2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altLang="zh-CN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TTCCAATCTCACAGCAAGCCG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altLang="zh-CN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TCCGCACTTTGGACATGGTTG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007821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NPR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altLang="zh-CN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GCACTCCAGATCTCAAAGCGT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altLang="zh-CN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AAGCCTCTCCTAGCACTGGA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8157270"/>
                  </a:ext>
                </a:extLst>
              </a:tr>
              <a:tr h="290621">
                <a:tc>
                  <a:txBody>
                    <a:bodyPr/>
                    <a:lstStyle/>
                    <a:p>
                      <a:pPr algn="ctr"/>
                      <a:r>
                        <a:rPr lang="en-US" sz="140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tin</a:t>
                      </a:r>
                      <a:endParaRPr lang="zh-CN" sz="140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ACAATGGAACTGGAA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CTTTGACTGGGCTTC</a:t>
                      </a:r>
                      <a:endParaRPr lang="zh-CN" sz="14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541638"/>
                  </a:ext>
                </a:extLst>
              </a:tr>
            </a:tbl>
          </a:graphicData>
        </a:graphic>
      </p:graphicFrame>
      <p:sp>
        <p:nvSpPr>
          <p:cNvPr id="11" name="文本框 10">
            <a:extLst>
              <a:ext uri="{FF2B5EF4-FFF2-40B4-BE49-F238E27FC236}">
                <a16:creationId xmlns:a16="http://schemas.microsoft.com/office/drawing/2014/main" id="{45A64A78-E896-A14C-BFF8-E0AE84592D0C}"/>
              </a:ext>
            </a:extLst>
          </p:cNvPr>
          <p:cNvSpPr txBox="1"/>
          <p:nvPr/>
        </p:nvSpPr>
        <p:spPr>
          <a:xfrm>
            <a:off x="3760940" y="817416"/>
            <a:ext cx="60939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06400" indent="-406400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able S1: Primers of genes for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qRT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-PCR</a:t>
            </a:r>
            <a:endParaRPr lang="zh-CN" altLang="zh-CN" sz="3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711536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B3DF9DE2-7088-694B-9C1D-5FFF10BDFF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9243729"/>
              </p:ext>
            </p:extLst>
          </p:nvPr>
        </p:nvGraphicFramePr>
        <p:xfrm>
          <a:off x="1889468" y="1034051"/>
          <a:ext cx="8657448" cy="519145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287848">
                  <a:extLst>
                    <a:ext uri="{9D8B030D-6E8A-4147-A177-3AD203B41FA5}">
                      <a16:colId xmlns:a16="http://schemas.microsoft.com/office/drawing/2014/main" val="1004842991"/>
                    </a:ext>
                  </a:extLst>
                </a:gridCol>
                <a:gridCol w="2548289">
                  <a:extLst>
                    <a:ext uri="{9D8B030D-6E8A-4147-A177-3AD203B41FA5}">
                      <a16:colId xmlns:a16="http://schemas.microsoft.com/office/drawing/2014/main" val="2457781055"/>
                    </a:ext>
                  </a:extLst>
                </a:gridCol>
                <a:gridCol w="2548289">
                  <a:extLst>
                    <a:ext uri="{9D8B030D-6E8A-4147-A177-3AD203B41FA5}">
                      <a16:colId xmlns:a16="http://schemas.microsoft.com/office/drawing/2014/main" val="1592215762"/>
                    </a:ext>
                  </a:extLst>
                </a:gridCol>
                <a:gridCol w="636885">
                  <a:extLst>
                    <a:ext uri="{9D8B030D-6E8A-4147-A177-3AD203B41FA5}">
                      <a16:colId xmlns:a16="http://schemas.microsoft.com/office/drawing/2014/main" val="321675211"/>
                    </a:ext>
                  </a:extLst>
                </a:gridCol>
                <a:gridCol w="636137">
                  <a:extLst>
                    <a:ext uri="{9D8B030D-6E8A-4147-A177-3AD203B41FA5}">
                      <a16:colId xmlns:a16="http://schemas.microsoft.com/office/drawing/2014/main" val="2172908832"/>
                    </a:ext>
                  </a:extLst>
                </a:gridCol>
              </a:tblGrid>
              <a:tr h="414170">
                <a:tc rowSpan="2"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ID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ection site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7804774"/>
                  </a:ext>
                </a:extLst>
              </a:tr>
              <a:tr h="4396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 (5' to 3')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 (5' to 3')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6916389"/>
                  </a:ext>
                </a:extLst>
              </a:tr>
              <a:tr h="853784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28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AACACGGGGGACGAGCTCATGGCTGCATT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CAGATCC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TGTCGACTCTAGAAATAGGAAGGAAGAAAT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CC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cI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5853278"/>
                  </a:ext>
                </a:extLst>
              </a:tr>
              <a:tr h="439614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29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CGGGATGGGAGCAGAATATTCA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TAGACCCAGTGGGGCAAAACAT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6175672"/>
                  </a:ext>
                </a:extLst>
              </a:tr>
              <a:tr h="441028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0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CGGGATGGGTAAAGAAATTTCAGA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TAGATTCTAACGACTCTATTGGGCAA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0397534"/>
                  </a:ext>
                </a:extLst>
              </a:tr>
              <a:tr h="441028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1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CGGGATGGCTTCGGCAGCCATTCTTT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TAGACGACTCTGTTGGGCAAAACG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6625733"/>
                  </a:ext>
                </a:extLst>
              </a:tr>
              <a:tr h="414170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2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CGGGATGGGGGAAGAATTTTCA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tabLst>
                          <a:tab pos="437515" algn="l"/>
                        </a:tabLst>
                      </a:pPr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TAGACGACTCTACTGGGCAAAAC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aI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8440594"/>
                  </a:ext>
                </a:extLst>
              </a:tr>
              <a:tr h="414170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3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CGGGATGGCAGCAATAAGCTCAA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TAGAGGTTGGGGGGCAAAATGTGA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2291286"/>
                  </a:ext>
                </a:extLst>
              </a:tr>
              <a:tr h="441028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7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GAGCTCATGGCATTCAACGTACTC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TAGAACAAAACTTAATCAAATAGTCAGCT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c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1346305"/>
                  </a:ext>
                </a:extLst>
              </a:tr>
              <a:tr h="441028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8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CGGGATGGCGATACCGAGCTCA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TAGAAAATAATGATCGTGAAGGAGTCGG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aI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6556793"/>
                  </a:ext>
                </a:extLst>
              </a:tr>
              <a:tr h="414170">
                <a:tc>
                  <a:txBody>
                    <a:bodyPr/>
                    <a:lstStyle/>
                    <a:p>
                      <a:r>
                        <a:rPr lang="en-US" sz="1400" b="1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LP39</a:t>
                      </a:r>
                      <a:endParaRPr lang="zh-CN" sz="1400" b="1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CGGGATGGCGATAAGCTCAAAG</a:t>
                      </a:r>
                      <a:endParaRPr lang="zh-CN" sz="1400" b="1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TAGAGCTATTTGTTGGGCAAAACG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maI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baI</a:t>
                      </a:r>
                      <a:endParaRPr lang="zh-CN" sz="14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9625617"/>
                  </a:ext>
                </a:extLst>
              </a:tr>
            </a:tbl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59E41873-A266-D44F-A63F-1A53C8BB92AD}"/>
              </a:ext>
            </a:extLst>
          </p:cNvPr>
          <p:cNvSpPr txBox="1"/>
          <p:nvPr/>
        </p:nvSpPr>
        <p:spPr>
          <a:xfrm>
            <a:off x="2909170" y="447829"/>
            <a:ext cx="60939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06400" indent="-406400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able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2: Primers of 9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CcTLP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gene for full-length amplification</a:t>
            </a:r>
            <a:endParaRPr lang="zh-CN" altLang="zh-CN" sz="3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0629193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3D08125-65E2-CA45-91C4-6DB648673D2D}"/>
              </a:ext>
            </a:extLst>
          </p:cNvPr>
          <p:cNvSpPr txBox="1"/>
          <p:nvPr/>
        </p:nvSpPr>
        <p:spPr>
          <a:xfrm>
            <a:off x="1930299" y="4551551"/>
            <a:ext cx="827800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1: Figure synteny regions between Pecan genome and hickory </a:t>
            </a:r>
            <a:r>
              <a:rPr lang="en-US" altLang="zh-CN" sz="1800" i="1" kern="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cTLP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genes located genomic regions</a:t>
            </a:r>
            <a:r>
              <a:rPr lang="zh-CN" altLang="zh-CN" dirty="0">
                <a:effectLst/>
              </a:rPr>
              <a:t> 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31E4CBE0-B718-2D40-92FE-3EF6E6DA64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4855" y="71481"/>
            <a:ext cx="10462486" cy="4197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2326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74B93BD-5A3C-8541-8178-8C84B18C8A70}"/>
              </a:ext>
            </a:extLst>
          </p:cNvPr>
          <p:cNvSpPr txBox="1"/>
          <p:nvPr/>
        </p:nvSpPr>
        <p:spPr>
          <a:xfrm>
            <a:off x="1088725" y="5262427"/>
            <a:ext cx="1001455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06400" indent="-406400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Figure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2: Multiple sequence alignment of hickory TLP sequences. Blue outline boxes</a:t>
            </a:r>
            <a:r>
              <a:rPr lang="zh-CN" altLang="en-US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indicated conserved regions, and dark red background represented consistent residual bases between 40 hickory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LP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genes.</a:t>
            </a:r>
            <a:endParaRPr lang="zh-CN" altLang="zh-CN" sz="3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BE442F0-2A1E-6243-A8F2-D0D524552D8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8725" y="0"/>
            <a:ext cx="10014550" cy="500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71156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4">
            <a:extLst>
              <a:ext uri="{FF2B5EF4-FFF2-40B4-BE49-F238E27FC236}">
                <a16:creationId xmlns:a16="http://schemas.microsoft.com/office/drawing/2014/main" id="{274B93BD-5A3C-8541-8178-8C84B18C8A70}"/>
              </a:ext>
            </a:extLst>
          </p:cNvPr>
          <p:cNvSpPr txBox="1"/>
          <p:nvPr/>
        </p:nvSpPr>
        <p:spPr>
          <a:xfrm>
            <a:off x="1427842" y="5370269"/>
            <a:ext cx="9559472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06400" indent="-406400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Figure S3:</a:t>
            </a:r>
            <a:r>
              <a:rPr lang="zh-CN" altLang="en-US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xpression analysis of SA-synthetic and signaling-related genes after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.dothide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ion by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</a:t>
            </a:r>
            <a:r>
              <a:rPr lang="en-US" altLang="zh-CN" dirty="0"/>
              <a:t>.</a:t>
            </a:r>
            <a:r>
              <a:rPr lang="zh-CN" altLang="zh-CN" sz="3200" dirty="0"/>
              <a:t> </a:t>
            </a:r>
            <a:endParaRPr lang="zh-CN" altLang="zh-CN" sz="3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12A2EF2-956A-5444-85E4-DA48BE66D4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0349" y="2038350"/>
            <a:ext cx="1854200" cy="27813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598D41D-A0D5-6748-9991-3A8B75D536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92621" y="2044700"/>
            <a:ext cx="1930400" cy="27686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055977C-6D73-F849-A532-48D46116C2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21093" y="2038350"/>
            <a:ext cx="1892300" cy="2781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1911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2</TotalTime>
  <Words>212</Words>
  <Application>Microsoft Macintosh PowerPoint</Application>
  <PresentationFormat>宽屏</PresentationFormat>
  <Paragraphs>100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Microsoft Office User</cp:lastModifiedBy>
  <cp:revision>5</cp:revision>
  <dcterms:created xsi:type="dcterms:W3CDTF">2022-01-05T07:38:54Z</dcterms:created>
  <dcterms:modified xsi:type="dcterms:W3CDTF">2022-03-04T09:16:52Z</dcterms:modified>
</cp:coreProperties>
</file>